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5" r:id="rId2"/>
    <p:sldId id="276" r:id="rId3"/>
    <p:sldId id="277" r:id="rId4"/>
  </p:sldIdLst>
  <p:sldSz cx="9144000" cy="8999538"/>
  <p:notesSz cx="6858000" cy="9144000"/>
  <p:custDataLst>
    <p:tags r:id="rId5"/>
  </p:custDataLst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93">
          <p15:clr>
            <a:srgbClr val="A4A3A4"/>
          </p15:clr>
        </p15:guide>
        <p15:guide id="2" pos="27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 autoAdjust="0"/>
    <p:restoredTop sz="94531" autoAdjust="0"/>
  </p:normalViewPr>
  <p:slideViewPr>
    <p:cSldViewPr>
      <p:cViewPr varScale="1">
        <p:scale>
          <a:sx n="79" d="100"/>
          <a:sy n="79" d="100"/>
        </p:scale>
        <p:origin x="1968" y="216"/>
      </p:cViewPr>
      <p:guideLst>
        <p:guide orient="horz" pos="2893"/>
        <p:guide pos="27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72842"/>
            <a:ext cx="7772400" cy="313317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726842"/>
            <a:ext cx="6858000" cy="217280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0A7251-0E8C-75D7-0353-3A2F74D31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6CF470-4D43-1F79-795B-6A2B3FD99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120218-BA73-604B-EDFE-A3CAEB0BB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275979-A780-BF4B-87EE-C926F08DB53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3267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243276-881E-0B80-D870-DB0252C3C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E6CB59-6118-B4A1-7D80-E10993134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C88CBD-738C-15A5-5063-CF2D6F8DC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3BD59B-5715-6B46-A0E3-C345E77676C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7984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79142"/>
            <a:ext cx="1971675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79142"/>
            <a:ext cx="5800725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9BE029-CC85-506E-8936-671CF04E0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D14B6D-86CD-1870-509D-25C30B3C0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35B758-E514-0902-0C61-5D96EBD69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2FDED-BE2F-8242-BE6C-B9E75758254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4036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E5CCA6-0F90-6D74-8FE3-AED98FA4D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70DB78-723B-3A6A-E4D8-39C6D828A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8F0A56-75FE-DF16-4017-3A500CDB6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B767F0-4F46-2941-AC2C-5BF24C00086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9537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243638"/>
            <a:ext cx="7886700" cy="374355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022610"/>
            <a:ext cx="7886700" cy="196864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CC104F-CCB1-4AEA-B91C-E69C5A027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BB5CB5-264B-1748-DCE2-07028E803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037476-E3BA-6820-11DC-1674113C3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EE2117-AD10-F549-B5F8-9A707651314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9906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C253E6B-0AFB-3486-57A5-13BB8FEFD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A1A1C0BF-7CE2-3E22-EBEC-3B79B0F1B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6334E8A6-15C6-3E08-B955-E90BA7D9F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6BDDE9-7361-C244-BB9A-06F4B2463FF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6778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79144"/>
            <a:ext cx="78867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206137"/>
            <a:ext cx="3868340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287331"/>
            <a:ext cx="3868340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206137"/>
            <a:ext cx="3887391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287331"/>
            <a:ext cx="3887391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4D93B79E-D0AF-06F3-E1BD-0DC3262BD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BCD4A294-5482-296C-E93E-7E724735B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781FD0A-D2AA-7275-C6DE-3C5DCDCFE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B32F14-F635-D843-ACA2-475B0042AAE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541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CBD69474-CF39-2D90-C9D8-288366AC0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2045D43B-3250-0BBD-5EF1-93F7B19EA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99BFCFFA-69CF-CF12-14A5-7156E3C6D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EA21DB-0B3D-2340-BD78-EB1BE476F81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052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C0DDF276-06D4-F35D-B324-4578B525A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B757285B-882C-0567-C71C-046EEC1E0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F9E9B7DB-EBFD-9788-7F94-8DDA27825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432B21-E99C-B84E-937F-3C7D3974BE3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2118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295769"/>
            <a:ext cx="4629150" cy="639550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6492B0A-A629-BA44-944F-3F891FB0A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B5676932-1C21-E322-4962-6CB788E01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F152613-F9E7-C4DB-EE7E-E3FEAC3BC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E185A7-3A12-FF40-AE2D-E1BF6D1B147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940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295769"/>
            <a:ext cx="4629150" cy="639550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CN" altLang="en-US" noProof="0"/>
              <a:t>单击图标添加图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0D3C6D5-E7BA-A6B8-ADBE-59D4120F0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1FAABF3-453E-8437-8E5F-69250F4DF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A67B03D-42BA-B828-B10D-FF1318623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04E825-9D6D-084A-8290-92B0A2A4F25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587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F5C1C96E-5645-8543-8E0B-8660487F4DC6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479425"/>
            <a:ext cx="7886700" cy="173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92261364-707C-5993-F5CF-BFD8EAD09708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28650" y="2395538"/>
            <a:ext cx="7886700" cy="5710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8EA03B-D128-37E9-171C-F17FCEC459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CC4A5B-388E-93FD-E232-209D64D365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8340725"/>
            <a:ext cx="30861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26C2FB-9C85-FE99-C136-3EC1A7F8C6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A6E21FB-F040-4E4B-82EE-26C944D7E96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3" name="图片 1">
            <a:extLst>
              <a:ext uri="{FF2B5EF4-FFF2-40B4-BE49-F238E27FC236}">
                <a16:creationId xmlns:a16="http://schemas.microsoft.com/office/drawing/2014/main" id="{614B9ABD-5F5A-C015-FC9B-E49126BEEF9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5" t="5598" r="4063" b="12659"/>
          <a:stretch>
            <a:fillRect/>
          </a:stretch>
        </p:blipFill>
        <p:spPr bwMode="auto">
          <a:xfrm>
            <a:off x="1771650" y="2551113"/>
            <a:ext cx="5329238" cy="2547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3794" name="文本框 30">
            <a:extLst>
              <a:ext uri="{FF2B5EF4-FFF2-40B4-BE49-F238E27FC236}">
                <a16:creationId xmlns:a16="http://schemas.microsoft.com/office/drawing/2014/main" id="{04363B53-880F-8433-44DB-A23DB07AAF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6513" y="1071563"/>
            <a:ext cx="5172076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-RU521</a:t>
            </a:r>
            <a:r>
              <a:rPr lang="zh-CN" altLang="en-US" sz="1800"/>
              <a:t>细胞</a:t>
            </a:r>
            <a:r>
              <a:rPr lang="en-US" altLang="zh-CN" sz="1800"/>
              <a:t>NLRP3</a:t>
            </a:r>
            <a:r>
              <a:rPr lang="en-US" altLang="zh-CN" sz="1800">
                <a:sym typeface="宋体" panose="02010600030101010101" pitchFamily="2" charset="-122"/>
              </a:rPr>
              <a:t>,</a:t>
            </a:r>
            <a:r>
              <a:rPr lang="en-US" altLang="zh-CN" sz="1800"/>
              <a:t>N=3</a:t>
            </a:r>
          </a:p>
        </p:txBody>
      </p:sp>
      <p:sp>
        <p:nvSpPr>
          <p:cNvPr id="33795" name="文本框 18">
            <a:extLst>
              <a:ext uri="{FF2B5EF4-FFF2-40B4-BE49-F238E27FC236}">
                <a16:creationId xmlns:a16="http://schemas.microsoft.com/office/drawing/2014/main" id="{9CD4A072-A62A-2010-C538-0CB2429E44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0325" y="2632075"/>
            <a:ext cx="8826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3796" name="文本框 19">
            <a:extLst>
              <a:ext uri="{FF2B5EF4-FFF2-40B4-BE49-F238E27FC236}">
                <a16:creationId xmlns:a16="http://schemas.microsoft.com/office/drawing/2014/main" id="{74FE3504-72FE-231B-E0C4-10CB71FC18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4450" y="2759075"/>
            <a:ext cx="8810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3797" name="文本框 20">
            <a:extLst>
              <a:ext uri="{FF2B5EF4-FFF2-40B4-BE49-F238E27FC236}">
                <a16:creationId xmlns:a16="http://schemas.microsoft.com/office/drawing/2014/main" id="{A592C33E-BBBB-9E3F-250F-5876C9C2BC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4450" y="2903538"/>
            <a:ext cx="8810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3798" name="文本框 21">
            <a:extLst>
              <a:ext uri="{FF2B5EF4-FFF2-40B4-BE49-F238E27FC236}">
                <a16:creationId xmlns:a16="http://schemas.microsoft.com/office/drawing/2014/main" id="{FA41C1A9-A8FD-19A4-93B5-31F673DC5E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7475" y="3089275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3799" name="文本框 22">
            <a:extLst>
              <a:ext uri="{FF2B5EF4-FFF2-40B4-BE49-F238E27FC236}">
                <a16:creationId xmlns:a16="http://schemas.microsoft.com/office/drawing/2014/main" id="{A8171D28-1269-B68D-3127-F9334C7175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3350" y="3421063"/>
            <a:ext cx="8112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3800" name="文本框 23">
            <a:extLst>
              <a:ext uri="{FF2B5EF4-FFF2-40B4-BE49-F238E27FC236}">
                <a16:creationId xmlns:a16="http://schemas.microsoft.com/office/drawing/2014/main" id="{C711A2F0-C0D8-384A-984D-B4E504A5F3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3350" y="3703638"/>
            <a:ext cx="7366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3801" name="文本框 24">
            <a:extLst>
              <a:ext uri="{FF2B5EF4-FFF2-40B4-BE49-F238E27FC236}">
                <a16:creationId xmlns:a16="http://schemas.microsoft.com/office/drawing/2014/main" id="{70919A06-861E-238D-5312-063164C9AB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7475" y="4048125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3802" name="文本框 25">
            <a:extLst>
              <a:ext uri="{FF2B5EF4-FFF2-40B4-BE49-F238E27FC236}">
                <a16:creationId xmlns:a16="http://schemas.microsoft.com/office/drawing/2014/main" id="{5310A709-53A6-7FB7-6AD9-9B23D23113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7475" y="4354513"/>
            <a:ext cx="7350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3803" name="文本框 26">
            <a:extLst>
              <a:ext uri="{FF2B5EF4-FFF2-40B4-BE49-F238E27FC236}">
                <a16:creationId xmlns:a16="http://schemas.microsoft.com/office/drawing/2014/main" id="{2099BAEF-4C4F-AF4F-9CF2-B7702F81CF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7475" y="4933950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7CFD19A9-A388-6300-DE8F-CE46365DD759}"/>
              </a:ext>
            </a:extLst>
          </p:cNvPr>
          <p:cNvSpPr/>
          <p:nvPr/>
        </p:nvSpPr>
        <p:spPr>
          <a:xfrm>
            <a:off x="2349500" y="3925888"/>
            <a:ext cx="4214813" cy="33337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0AB90D4F-2671-3616-0AEA-CC8993CF67C4}"/>
              </a:ext>
            </a:extLst>
          </p:cNvPr>
          <p:cNvSpPr/>
          <p:nvPr/>
        </p:nvSpPr>
        <p:spPr>
          <a:xfrm>
            <a:off x="2405063" y="2878138"/>
            <a:ext cx="4103687" cy="31432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3806" name="文本框 56">
            <a:extLst>
              <a:ext uri="{FF2B5EF4-FFF2-40B4-BE49-F238E27FC236}">
                <a16:creationId xmlns:a16="http://schemas.microsoft.com/office/drawing/2014/main" id="{103EDE99-780D-4827-DAD0-EBD197666A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1388" y="2522538"/>
            <a:ext cx="11985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  <a:sym typeface="宋体" panose="02010600030101010101" pitchFamily="2" charset="-122"/>
              </a:rPr>
              <a:t>Nrf2</a:t>
            </a: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3807" name="文本框 56">
            <a:extLst>
              <a:ext uri="{FF2B5EF4-FFF2-40B4-BE49-F238E27FC236}">
                <a16:creationId xmlns:a16="http://schemas.microsoft.com/office/drawing/2014/main" id="{0E5C6404-9322-A61A-89BB-2B0B5A895F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92725" y="4295775"/>
            <a:ext cx="97948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33808" name="文本框 3">
            <a:extLst>
              <a:ext uri="{FF2B5EF4-FFF2-40B4-BE49-F238E27FC236}">
                <a16:creationId xmlns:a16="http://schemas.microsoft.com/office/drawing/2014/main" id="{4E7DA331-BBFC-7441-6C6D-9A2C9A0FF62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424907" y="2137569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3809" name="文本框 4">
            <a:extLst>
              <a:ext uri="{FF2B5EF4-FFF2-40B4-BE49-F238E27FC236}">
                <a16:creationId xmlns:a16="http://schemas.microsoft.com/office/drawing/2014/main" id="{5B689BC7-6C8B-9936-62FC-69ADD67CA44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666206" y="2086769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3810" name="文本框 5">
            <a:extLst>
              <a:ext uri="{FF2B5EF4-FFF2-40B4-BE49-F238E27FC236}">
                <a16:creationId xmlns:a16="http://schemas.microsoft.com/office/drawing/2014/main" id="{4A4C9E63-0904-3CDB-E402-297AE219618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17837" y="2138363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3811" name="文本框 6">
            <a:extLst>
              <a:ext uri="{FF2B5EF4-FFF2-40B4-BE49-F238E27FC236}">
                <a16:creationId xmlns:a16="http://schemas.microsoft.com/office/drawing/2014/main" id="{2BE22E97-4780-A61B-DEEF-4FFCCE67AF2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62325" y="2138363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</a:p>
        </p:txBody>
      </p:sp>
      <p:sp>
        <p:nvSpPr>
          <p:cNvPr id="33812" name="文本框 7">
            <a:extLst>
              <a:ext uri="{FF2B5EF4-FFF2-40B4-BE49-F238E27FC236}">
                <a16:creationId xmlns:a16="http://schemas.microsoft.com/office/drawing/2014/main" id="{C38E5A69-6562-972F-2311-FEF7FF53A66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99656" y="1907382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3813" name="文本框 8">
            <a:extLst>
              <a:ext uri="{FF2B5EF4-FFF2-40B4-BE49-F238E27FC236}">
                <a16:creationId xmlns:a16="http://schemas.microsoft.com/office/drawing/2014/main" id="{2D764505-469F-1C4B-EFAA-42FC379023E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940968" y="1907382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3814" name="文本框 9">
            <a:extLst>
              <a:ext uri="{FF2B5EF4-FFF2-40B4-BE49-F238E27FC236}">
                <a16:creationId xmlns:a16="http://schemas.microsoft.com/office/drawing/2014/main" id="{5B4BC8FA-2615-81C9-0BAA-5F53B39E3B9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64025" y="1841501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3815" name="文本框 10">
            <a:extLst>
              <a:ext uri="{FF2B5EF4-FFF2-40B4-BE49-F238E27FC236}">
                <a16:creationId xmlns:a16="http://schemas.microsoft.com/office/drawing/2014/main" id="{D43FE755-390B-D2B1-5CF0-B7A513D87E0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60887" y="1830388"/>
            <a:ext cx="12477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3816" name="文本框 11">
            <a:extLst>
              <a:ext uri="{FF2B5EF4-FFF2-40B4-BE49-F238E27FC236}">
                <a16:creationId xmlns:a16="http://schemas.microsoft.com/office/drawing/2014/main" id="{85FAD9FC-28F0-FB6A-F7F4-54E3646D4C5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906963" y="1839913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3817" name="文本框 9">
            <a:extLst>
              <a:ext uri="{FF2B5EF4-FFF2-40B4-BE49-F238E27FC236}">
                <a16:creationId xmlns:a16="http://schemas.microsoft.com/office/drawing/2014/main" id="{8C759787-5B8F-4293-56EF-D174355A6B8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249862" y="183991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3818" name="文本框 10">
            <a:extLst>
              <a:ext uri="{FF2B5EF4-FFF2-40B4-BE49-F238E27FC236}">
                <a16:creationId xmlns:a16="http://schemas.microsoft.com/office/drawing/2014/main" id="{779523AF-C7E4-7DF0-8924-8BB00B0A4F2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550694" y="1829594"/>
            <a:ext cx="12461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3819" name="文本框 11">
            <a:extLst>
              <a:ext uri="{FF2B5EF4-FFF2-40B4-BE49-F238E27FC236}">
                <a16:creationId xmlns:a16="http://schemas.microsoft.com/office/drawing/2014/main" id="{60AB8884-0606-8463-9007-ED238041B04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840412" y="1751013"/>
            <a:ext cx="14255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7" name="图片 3" descr="Cleave-caspae1">
            <a:extLst>
              <a:ext uri="{FF2B5EF4-FFF2-40B4-BE49-F238E27FC236}">
                <a16:creationId xmlns:a16="http://schemas.microsoft.com/office/drawing/2014/main" id="{966F38D2-71AD-56AB-3DB6-77586FE8C9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5"/>
          <a:stretch>
            <a:fillRect/>
          </a:stretch>
        </p:blipFill>
        <p:spPr bwMode="auto">
          <a:xfrm>
            <a:off x="1908175" y="2484438"/>
            <a:ext cx="5200650" cy="3027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818" name="文本框 30">
            <a:extLst>
              <a:ext uri="{FF2B5EF4-FFF2-40B4-BE49-F238E27FC236}">
                <a16:creationId xmlns:a16="http://schemas.microsoft.com/office/drawing/2014/main" id="{EF1E7D27-EF87-B4F7-3B42-7F74E3A48D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925" y="1154113"/>
            <a:ext cx="43148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-RU521</a:t>
            </a:r>
            <a:r>
              <a:rPr lang="zh-CN" altLang="en-US" sz="1800"/>
              <a:t>细胞</a:t>
            </a:r>
            <a:r>
              <a:rPr lang="en-US" altLang="zh-CN" sz="1800"/>
              <a:t> caspase1</a:t>
            </a:r>
            <a:r>
              <a:rPr lang="zh-CN" altLang="en-US" sz="1800"/>
              <a:t>，</a:t>
            </a:r>
            <a:r>
              <a:rPr lang="en-US" altLang="zh-CN" sz="1800"/>
              <a:t>n=3</a:t>
            </a:r>
          </a:p>
        </p:txBody>
      </p:sp>
      <p:sp>
        <p:nvSpPr>
          <p:cNvPr id="34819" name="文本框 18">
            <a:extLst>
              <a:ext uri="{FF2B5EF4-FFF2-40B4-BE49-F238E27FC236}">
                <a16:creationId xmlns:a16="http://schemas.microsoft.com/office/drawing/2014/main" id="{45262AC0-7FE9-4F67-4A42-3BACBB3E5E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0325" y="2632075"/>
            <a:ext cx="8826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4820" name="文本框 19">
            <a:extLst>
              <a:ext uri="{FF2B5EF4-FFF2-40B4-BE49-F238E27FC236}">
                <a16:creationId xmlns:a16="http://schemas.microsoft.com/office/drawing/2014/main" id="{FC5228ED-86AD-E611-9214-B3C304F03F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4450" y="2759075"/>
            <a:ext cx="8810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4821" name="文本框 20">
            <a:extLst>
              <a:ext uri="{FF2B5EF4-FFF2-40B4-BE49-F238E27FC236}">
                <a16:creationId xmlns:a16="http://schemas.microsoft.com/office/drawing/2014/main" id="{BA09ADC8-0FFD-3DDC-DCBE-C852B77B4C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4450" y="2974975"/>
            <a:ext cx="8810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4822" name="文本框 21">
            <a:extLst>
              <a:ext uri="{FF2B5EF4-FFF2-40B4-BE49-F238E27FC236}">
                <a16:creationId xmlns:a16="http://schemas.microsoft.com/office/drawing/2014/main" id="{26EAB94E-02D6-C834-B1F8-9C4DFF6BD4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7475" y="3162300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4823" name="文本框 22">
            <a:extLst>
              <a:ext uri="{FF2B5EF4-FFF2-40B4-BE49-F238E27FC236}">
                <a16:creationId xmlns:a16="http://schemas.microsoft.com/office/drawing/2014/main" id="{8AC295BB-FF23-5A1F-979A-2FD73070B8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3350" y="3492500"/>
            <a:ext cx="8112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4824" name="文本框 23">
            <a:extLst>
              <a:ext uri="{FF2B5EF4-FFF2-40B4-BE49-F238E27FC236}">
                <a16:creationId xmlns:a16="http://schemas.microsoft.com/office/drawing/2014/main" id="{36EE538A-63EE-EE0D-ADA0-8D6BC8E798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3350" y="3848100"/>
            <a:ext cx="7366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4825" name="文本框 24">
            <a:extLst>
              <a:ext uri="{FF2B5EF4-FFF2-40B4-BE49-F238E27FC236}">
                <a16:creationId xmlns:a16="http://schemas.microsoft.com/office/drawing/2014/main" id="{09C0EFEF-AEBD-B7E4-26CB-73793D5316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7475" y="4191000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4826" name="文本框 25">
            <a:extLst>
              <a:ext uri="{FF2B5EF4-FFF2-40B4-BE49-F238E27FC236}">
                <a16:creationId xmlns:a16="http://schemas.microsoft.com/office/drawing/2014/main" id="{A5EF8B4C-5EE4-D320-5F4C-E0EA7182C6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7475" y="4497388"/>
            <a:ext cx="7350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4827" name="文本框 26">
            <a:extLst>
              <a:ext uri="{FF2B5EF4-FFF2-40B4-BE49-F238E27FC236}">
                <a16:creationId xmlns:a16="http://schemas.microsoft.com/office/drawing/2014/main" id="{34CC3C10-80A0-DCF7-820D-CF9ADD8A53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7475" y="5148263"/>
            <a:ext cx="7350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788B2FFD-AE06-0800-F151-D31AA9B53899}"/>
              </a:ext>
            </a:extLst>
          </p:cNvPr>
          <p:cNvSpPr/>
          <p:nvPr/>
        </p:nvSpPr>
        <p:spPr>
          <a:xfrm>
            <a:off x="2508250" y="5008563"/>
            <a:ext cx="4162425" cy="33337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4829" name="文本框 56">
            <a:extLst>
              <a:ext uri="{FF2B5EF4-FFF2-40B4-BE49-F238E27FC236}">
                <a16:creationId xmlns:a16="http://schemas.microsoft.com/office/drawing/2014/main" id="{4A7D23E3-F0B8-C362-B40B-835DF6930C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7188" y="3794125"/>
            <a:ext cx="101123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8C39E42B-A565-239F-6854-4EE04B1AC3F7}"/>
              </a:ext>
            </a:extLst>
          </p:cNvPr>
          <p:cNvSpPr/>
          <p:nvPr/>
        </p:nvSpPr>
        <p:spPr>
          <a:xfrm>
            <a:off x="2579688" y="4125913"/>
            <a:ext cx="4027487" cy="31591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4831" name="文本框 56">
            <a:extLst>
              <a:ext uri="{FF2B5EF4-FFF2-40B4-BE49-F238E27FC236}">
                <a16:creationId xmlns:a16="http://schemas.microsoft.com/office/drawing/2014/main" id="{A2E07E86-D93B-EB26-79FF-8A6A1D93A7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5400" y="5364163"/>
            <a:ext cx="17462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  <a:sym typeface="宋体" panose="02010600030101010101" pitchFamily="2" charset="-122"/>
              </a:rPr>
              <a:t> caspase1</a:t>
            </a: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4832" name="文本框 3">
            <a:extLst>
              <a:ext uri="{FF2B5EF4-FFF2-40B4-BE49-F238E27FC236}">
                <a16:creationId xmlns:a16="http://schemas.microsoft.com/office/drawing/2014/main" id="{1F2661BB-99D0-FBFC-78AA-9265EF8A427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783682" y="2137569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4833" name="文本框 4">
            <a:extLst>
              <a:ext uri="{FF2B5EF4-FFF2-40B4-BE49-F238E27FC236}">
                <a16:creationId xmlns:a16="http://schemas.microsoft.com/office/drawing/2014/main" id="{B611A566-7C92-8495-940B-B4F1F4B9DA1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24981" y="2086769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4834" name="文本框 5">
            <a:extLst>
              <a:ext uri="{FF2B5EF4-FFF2-40B4-BE49-F238E27FC236}">
                <a16:creationId xmlns:a16="http://schemas.microsoft.com/office/drawing/2014/main" id="{057FA9BE-C02D-0388-0BF5-116C33E603D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04382" y="2137569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4835" name="文本框 6">
            <a:extLst>
              <a:ext uri="{FF2B5EF4-FFF2-40B4-BE49-F238E27FC236}">
                <a16:creationId xmlns:a16="http://schemas.microsoft.com/office/drawing/2014/main" id="{291ABFD4-AFCD-5B25-E9D9-6C68B2F5D3C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649663" y="2138363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</a:p>
        </p:txBody>
      </p:sp>
      <p:sp>
        <p:nvSpPr>
          <p:cNvPr id="34836" name="文本框 7">
            <a:extLst>
              <a:ext uri="{FF2B5EF4-FFF2-40B4-BE49-F238E27FC236}">
                <a16:creationId xmlns:a16="http://schemas.microsoft.com/office/drawing/2014/main" id="{B98E2F20-A2A7-4315-E4B3-2D96992FDC4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13968" y="1907382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4837" name="文本框 8">
            <a:extLst>
              <a:ext uri="{FF2B5EF4-FFF2-40B4-BE49-F238E27FC236}">
                <a16:creationId xmlns:a16="http://schemas.microsoft.com/office/drawing/2014/main" id="{8E5886CC-4483-F951-A499-126AF21829B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156868" y="1907382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4838" name="文本框 9">
            <a:extLst>
              <a:ext uri="{FF2B5EF4-FFF2-40B4-BE49-F238E27FC236}">
                <a16:creationId xmlns:a16="http://schemas.microsoft.com/office/drawing/2014/main" id="{7C285A5E-0F96-11F1-EF5A-5B186E547B6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78337" y="1841501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4839" name="文本框 10">
            <a:extLst>
              <a:ext uri="{FF2B5EF4-FFF2-40B4-BE49-F238E27FC236}">
                <a16:creationId xmlns:a16="http://schemas.microsoft.com/office/drawing/2014/main" id="{E2D988C3-8744-8233-EC39-942D49034DC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776787" y="1830388"/>
            <a:ext cx="12477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4840" name="文本框 11">
            <a:extLst>
              <a:ext uri="{FF2B5EF4-FFF2-40B4-BE49-F238E27FC236}">
                <a16:creationId xmlns:a16="http://schemas.microsoft.com/office/drawing/2014/main" id="{16F0FAFB-B888-D24D-D019-67293F19943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22863" y="1839913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4841" name="文本框 9">
            <a:extLst>
              <a:ext uri="{FF2B5EF4-FFF2-40B4-BE49-F238E27FC236}">
                <a16:creationId xmlns:a16="http://schemas.microsoft.com/office/drawing/2014/main" id="{3A7E9FA5-EFBE-2DEA-B3A2-9C9F7A19C75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65762" y="1841501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4842" name="文本框 10">
            <a:extLst>
              <a:ext uri="{FF2B5EF4-FFF2-40B4-BE49-F238E27FC236}">
                <a16:creationId xmlns:a16="http://schemas.microsoft.com/office/drawing/2014/main" id="{726CCC63-65D5-8E18-797E-DE82972E762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66594" y="1829594"/>
            <a:ext cx="12461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4843" name="文本框 11">
            <a:extLst>
              <a:ext uri="{FF2B5EF4-FFF2-40B4-BE49-F238E27FC236}">
                <a16:creationId xmlns:a16="http://schemas.microsoft.com/office/drawing/2014/main" id="{F2677F62-A9B7-DB84-E26F-0B7912446D8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056312" y="1751013"/>
            <a:ext cx="14255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1" name="图片 3" descr="gsdmd-n">
            <a:extLst>
              <a:ext uri="{FF2B5EF4-FFF2-40B4-BE49-F238E27FC236}">
                <a16:creationId xmlns:a16="http://schemas.microsoft.com/office/drawing/2014/main" id="{5E7D4342-C6CD-6C1D-9BAD-D44E61526D4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14"/>
          <a:stretch>
            <a:fillRect/>
          </a:stretch>
        </p:blipFill>
        <p:spPr bwMode="auto">
          <a:xfrm>
            <a:off x="2411413" y="1979613"/>
            <a:ext cx="5105400" cy="2403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842" name="图片 4" descr="gsdmd">
            <a:extLst>
              <a:ext uri="{FF2B5EF4-FFF2-40B4-BE49-F238E27FC236}">
                <a16:creationId xmlns:a16="http://schemas.microsoft.com/office/drawing/2014/main" id="{0C8088A7-A3B2-FE76-54A4-5B737CFD07E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1" b="7640"/>
          <a:stretch>
            <a:fillRect/>
          </a:stretch>
        </p:blipFill>
        <p:spPr bwMode="auto">
          <a:xfrm>
            <a:off x="2339975" y="5507038"/>
            <a:ext cx="5191125" cy="2406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843" name="文本框 30">
            <a:extLst>
              <a:ext uri="{FF2B5EF4-FFF2-40B4-BE49-F238E27FC236}">
                <a16:creationId xmlns:a16="http://schemas.microsoft.com/office/drawing/2014/main" id="{6109FBCB-39C8-FBEA-6D58-76F9F22ABE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43529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-RU521</a:t>
            </a:r>
            <a:r>
              <a:rPr lang="zh-CN" altLang="en-US" sz="1800"/>
              <a:t>细胞</a:t>
            </a:r>
            <a:r>
              <a:rPr lang="en-US" altLang="zh-CN" sz="1800"/>
              <a:t>GSDMD-N</a:t>
            </a:r>
            <a:r>
              <a:rPr lang="en-US" altLang="zh-CN" sz="1800">
                <a:sym typeface="宋体" panose="02010600030101010101" pitchFamily="2" charset="-122"/>
              </a:rPr>
              <a:t>,</a:t>
            </a:r>
            <a:r>
              <a:rPr lang="en-US" altLang="zh-CN" sz="1800"/>
              <a:t>N=3</a:t>
            </a:r>
          </a:p>
        </p:txBody>
      </p:sp>
      <p:sp>
        <p:nvSpPr>
          <p:cNvPr id="35844" name="文本框 18">
            <a:extLst>
              <a:ext uri="{FF2B5EF4-FFF2-40B4-BE49-F238E27FC236}">
                <a16:creationId xmlns:a16="http://schemas.microsoft.com/office/drawing/2014/main" id="{F4753562-1927-BE0F-07D4-D97D5A88B7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3563" y="2201863"/>
            <a:ext cx="766762" cy="206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5845" name="文本框 19">
            <a:extLst>
              <a:ext uri="{FF2B5EF4-FFF2-40B4-BE49-F238E27FC236}">
                <a16:creationId xmlns:a16="http://schemas.microsoft.com/office/drawing/2014/main" id="{CF9B3E8B-7FEC-B0C7-E298-F47E6007F8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7688" y="2328863"/>
            <a:ext cx="763587" cy="206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5846" name="文本框 20">
            <a:extLst>
              <a:ext uri="{FF2B5EF4-FFF2-40B4-BE49-F238E27FC236}">
                <a16:creationId xmlns:a16="http://schemas.microsoft.com/office/drawing/2014/main" id="{6C53DABD-1C74-113C-BD02-B705EFB775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7688" y="2400300"/>
            <a:ext cx="763587" cy="206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5847" name="文本框 21">
            <a:extLst>
              <a:ext uri="{FF2B5EF4-FFF2-40B4-BE49-F238E27FC236}">
                <a16:creationId xmlns:a16="http://schemas.microsoft.com/office/drawing/2014/main" id="{40945C64-6763-8D3F-822C-D97BB8D8CE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0713" y="2659063"/>
            <a:ext cx="636587" cy="206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5848" name="文本框 22">
            <a:extLst>
              <a:ext uri="{FF2B5EF4-FFF2-40B4-BE49-F238E27FC236}">
                <a16:creationId xmlns:a16="http://schemas.microsoft.com/office/drawing/2014/main" id="{015E32E1-6F5D-4868-732C-C36DF3E5EC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6588" y="2846388"/>
            <a:ext cx="703262" cy="207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5849" name="文本框 23">
            <a:extLst>
              <a:ext uri="{FF2B5EF4-FFF2-40B4-BE49-F238E27FC236}">
                <a16:creationId xmlns:a16="http://schemas.microsoft.com/office/drawing/2014/main" id="{ACE243AF-408B-4D3E-0AD4-9B82CEDC34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6588" y="3130550"/>
            <a:ext cx="639762" cy="206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5850" name="文本框 24">
            <a:extLst>
              <a:ext uri="{FF2B5EF4-FFF2-40B4-BE49-F238E27FC236}">
                <a16:creationId xmlns:a16="http://schemas.microsoft.com/office/drawing/2014/main" id="{2CD92A78-332C-2AB2-BD72-EE835412BA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0713" y="3402013"/>
            <a:ext cx="636587" cy="206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5851" name="文本框 25">
            <a:extLst>
              <a:ext uri="{FF2B5EF4-FFF2-40B4-BE49-F238E27FC236}">
                <a16:creationId xmlns:a16="http://schemas.microsoft.com/office/drawing/2014/main" id="{24DD846C-2D67-F9CB-1010-7500A37155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0713" y="3708400"/>
            <a:ext cx="636587" cy="207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5852" name="文本框 26">
            <a:extLst>
              <a:ext uri="{FF2B5EF4-FFF2-40B4-BE49-F238E27FC236}">
                <a16:creationId xmlns:a16="http://schemas.microsoft.com/office/drawing/2014/main" id="{219203D6-A3AD-3B59-CF66-C82FA86E00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0713" y="4071938"/>
            <a:ext cx="636587" cy="207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35853" name="文本框 18">
            <a:extLst>
              <a:ext uri="{FF2B5EF4-FFF2-40B4-BE49-F238E27FC236}">
                <a16:creationId xmlns:a16="http://schemas.microsoft.com/office/drawing/2014/main" id="{FFA84C60-9DE2-62CB-1BA3-42AA30EF12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6100" y="5629275"/>
            <a:ext cx="777875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5854" name="文本框 19">
            <a:extLst>
              <a:ext uri="{FF2B5EF4-FFF2-40B4-BE49-F238E27FC236}">
                <a16:creationId xmlns:a16="http://schemas.microsoft.com/office/drawing/2014/main" id="{24378693-01BA-6796-174D-51C91CB66F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0225" y="5756275"/>
            <a:ext cx="776288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5855" name="文本框 20">
            <a:extLst>
              <a:ext uri="{FF2B5EF4-FFF2-40B4-BE49-F238E27FC236}">
                <a16:creationId xmlns:a16="http://schemas.microsoft.com/office/drawing/2014/main" id="{24613B18-0476-4737-37F8-9703588C40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0225" y="5900738"/>
            <a:ext cx="776288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5856" name="文本框 21">
            <a:extLst>
              <a:ext uri="{FF2B5EF4-FFF2-40B4-BE49-F238E27FC236}">
                <a16:creationId xmlns:a16="http://schemas.microsoft.com/office/drawing/2014/main" id="{D0C8EE00-63E8-1B6F-899D-CA560993A4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4838" y="6172200"/>
            <a:ext cx="644525" cy="185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5857" name="文本框 22">
            <a:extLst>
              <a:ext uri="{FF2B5EF4-FFF2-40B4-BE49-F238E27FC236}">
                <a16:creationId xmlns:a16="http://schemas.microsoft.com/office/drawing/2014/main" id="{5B7E00C2-A943-6C46-673E-7494E33266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2300" y="6357938"/>
            <a:ext cx="709613" cy="185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5858" name="文本框 23">
            <a:extLst>
              <a:ext uri="{FF2B5EF4-FFF2-40B4-BE49-F238E27FC236}">
                <a16:creationId xmlns:a16="http://schemas.microsoft.com/office/drawing/2014/main" id="{0742C864-153F-EDA2-CFE9-9B4BE59C0A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2300" y="6642100"/>
            <a:ext cx="642938" cy="185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5859" name="文本框 24">
            <a:extLst>
              <a:ext uri="{FF2B5EF4-FFF2-40B4-BE49-F238E27FC236}">
                <a16:creationId xmlns:a16="http://schemas.microsoft.com/office/drawing/2014/main" id="{50AF9C07-73FF-D78B-91CA-6A5A40CE98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4838" y="6842125"/>
            <a:ext cx="644525" cy="185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5860" name="文本框 25">
            <a:extLst>
              <a:ext uri="{FF2B5EF4-FFF2-40B4-BE49-F238E27FC236}">
                <a16:creationId xmlns:a16="http://schemas.microsoft.com/office/drawing/2014/main" id="{11FFDAA8-B20B-136B-F2CB-FFE0A2CF58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4838" y="7148513"/>
            <a:ext cx="644525" cy="185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5861" name="文本框 26">
            <a:extLst>
              <a:ext uri="{FF2B5EF4-FFF2-40B4-BE49-F238E27FC236}">
                <a16:creationId xmlns:a16="http://schemas.microsoft.com/office/drawing/2014/main" id="{F6530212-022A-2522-7DF4-E09A34F933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4838" y="7583488"/>
            <a:ext cx="644525" cy="18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A95A5587-1F6C-094D-DB35-5F06E329C9C8}"/>
              </a:ext>
            </a:extLst>
          </p:cNvPr>
          <p:cNvSpPr/>
          <p:nvPr/>
        </p:nvSpPr>
        <p:spPr>
          <a:xfrm>
            <a:off x="2865438" y="6804025"/>
            <a:ext cx="3873500" cy="28416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58AE39E0-78C7-30D0-D67E-BC3921429624}"/>
              </a:ext>
            </a:extLst>
          </p:cNvPr>
          <p:cNvSpPr/>
          <p:nvPr/>
        </p:nvSpPr>
        <p:spPr>
          <a:xfrm>
            <a:off x="2965450" y="3490913"/>
            <a:ext cx="3573463" cy="26511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5864" name="文本框 56">
            <a:extLst>
              <a:ext uri="{FF2B5EF4-FFF2-40B4-BE49-F238E27FC236}">
                <a16:creationId xmlns:a16="http://schemas.microsoft.com/office/drawing/2014/main" id="{1CFE844A-CE0F-BC58-51D5-53B85905B2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1063" y="7091363"/>
            <a:ext cx="1236662" cy="288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35865" name="文本框 56">
            <a:extLst>
              <a:ext uri="{FF2B5EF4-FFF2-40B4-BE49-F238E27FC236}">
                <a16:creationId xmlns:a16="http://schemas.microsoft.com/office/drawing/2014/main" id="{A350A29D-870D-A175-722C-003E58D089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9413" y="3806825"/>
            <a:ext cx="1414462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  <a:sym typeface="宋体" panose="02010600030101010101" pitchFamily="2" charset="-122"/>
              </a:rPr>
              <a:t>GSDMD-N</a:t>
            </a: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C445C7CD-0D77-F05E-BC64-265D0AB58FCF}"/>
              </a:ext>
            </a:extLst>
          </p:cNvPr>
          <p:cNvSpPr/>
          <p:nvPr/>
        </p:nvSpPr>
        <p:spPr>
          <a:xfrm>
            <a:off x="2865438" y="6278563"/>
            <a:ext cx="3873500" cy="27146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5867" name="文本框 56">
            <a:extLst>
              <a:ext uri="{FF2B5EF4-FFF2-40B4-BE49-F238E27FC236}">
                <a16:creationId xmlns:a16="http://schemas.microsoft.com/office/drawing/2014/main" id="{D9F5713A-581D-0F1F-6FB3-BAC99C46C2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7250" y="5937250"/>
            <a:ext cx="1338263" cy="290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  <a:sym typeface="宋体" panose="02010600030101010101" pitchFamily="2" charset="-122"/>
              </a:rPr>
              <a:t>GSDMD</a:t>
            </a: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5868" name="文本框 3">
            <a:extLst>
              <a:ext uri="{FF2B5EF4-FFF2-40B4-BE49-F238E27FC236}">
                <a16:creationId xmlns:a16="http://schemas.microsoft.com/office/drawing/2014/main" id="{682037ED-3CF7-821D-EB3C-9330C9B02BD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954337" y="1693863"/>
            <a:ext cx="50641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5869" name="文本框 4">
            <a:extLst>
              <a:ext uri="{FF2B5EF4-FFF2-40B4-BE49-F238E27FC236}">
                <a16:creationId xmlns:a16="http://schemas.microsoft.com/office/drawing/2014/main" id="{F17CE530-D27E-3086-883C-1146DA5C49A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200400" y="1639888"/>
            <a:ext cx="593725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5870" name="文本框 5">
            <a:extLst>
              <a:ext uri="{FF2B5EF4-FFF2-40B4-BE49-F238E27FC236}">
                <a16:creationId xmlns:a16="http://schemas.microsoft.com/office/drawing/2014/main" id="{C4271F30-6648-58ED-52ED-F131F0F27E5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46475" y="1692276"/>
            <a:ext cx="5048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71" name="文本框 6">
            <a:extLst>
              <a:ext uri="{FF2B5EF4-FFF2-40B4-BE49-F238E27FC236}">
                <a16:creationId xmlns:a16="http://schemas.microsoft.com/office/drawing/2014/main" id="{601FD744-61A2-F9B7-F4C2-8CF84EE1D89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89376" y="1693862"/>
            <a:ext cx="5080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</a:p>
        </p:txBody>
      </p:sp>
      <p:sp>
        <p:nvSpPr>
          <p:cNvPr id="35872" name="文本框 7">
            <a:extLst>
              <a:ext uri="{FF2B5EF4-FFF2-40B4-BE49-F238E27FC236}">
                <a16:creationId xmlns:a16="http://schemas.microsoft.com/office/drawing/2014/main" id="{559B2718-79F4-B626-C1B7-B29D643C219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015582" y="1443831"/>
            <a:ext cx="984250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73" name="文本框 8">
            <a:extLst>
              <a:ext uri="{FF2B5EF4-FFF2-40B4-BE49-F238E27FC236}">
                <a16:creationId xmlns:a16="http://schemas.microsoft.com/office/drawing/2014/main" id="{9314E25C-982A-DAFD-EF06-EBC84F2167A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85457" y="1443831"/>
            <a:ext cx="984250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74" name="文本框 9">
            <a:extLst>
              <a:ext uri="{FF2B5EF4-FFF2-40B4-BE49-F238E27FC236}">
                <a16:creationId xmlns:a16="http://schemas.microsoft.com/office/drawing/2014/main" id="{98722847-2B01-106F-BDB4-46B31D51EA4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43426" y="1373187"/>
            <a:ext cx="11239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75" name="文本框 10">
            <a:extLst>
              <a:ext uri="{FF2B5EF4-FFF2-40B4-BE49-F238E27FC236}">
                <a16:creationId xmlns:a16="http://schemas.microsoft.com/office/drawing/2014/main" id="{14F314BC-2ED4-1F24-994E-A05B42D360F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846637" y="1362076"/>
            <a:ext cx="114617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76" name="文本框 11">
            <a:extLst>
              <a:ext uri="{FF2B5EF4-FFF2-40B4-BE49-F238E27FC236}">
                <a16:creationId xmlns:a16="http://schemas.microsoft.com/office/drawing/2014/main" id="{E1774F92-8C79-ECE3-D981-FA81F1978B9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86363" y="1371600"/>
            <a:ext cx="11287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77" name="文本框 9">
            <a:extLst>
              <a:ext uri="{FF2B5EF4-FFF2-40B4-BE49-F238E27FC236}">
                <a16:creationId xmlns:a16="http://schemas.microsoft.com/office/drawing/2014/main" id="{DEDC6CC5-6423-16E7-7E2E-2C61A253057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59413" y="1371600"/>
            <a:ext cx="11239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78" name="文本框 10">
            <a:extLst>
              <a:ext uri="{FF2B5EF4-FFF2-40B4-BE49-F238E27FC236}">
                <a16:creationId xmlns:a16="http://schemas.microsoft.com/office/drawing/2014/main" id="{45CDAD42-657C-9880-828A-E4FEDA1FD89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61831" y="1361282"/>
            <a:ext cx="11461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79" name="文本框 11">
            <a:extLst>
              <a:ext uri="{FF2B5EF4-FFF2-40B4-BE49-F238E27FC236}">
                <a16:creationId xmlns:a16="http://schemas.microsoft.com/office/drawing/2014/main" id="{A14B8350-FE70-C947-241F-9AC19E4CCC2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062663" y="1274762"/>
            <a:ext cx="13081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80" name="文本框 3">
            <a:extLst>
              <a:ext uri="{FF2B5EF4-FFF2-40B4-BE49-F238E27FC236}">
                <a16:creationId xmlns:a16="http://schemas.microsoft.com/office/drawing/2014/main" id="{16D2639E-71E4-EBB5-8B09-F20CEA89E23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938462" y="5192713"/>
            <a:ext cx="50641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5881" name="文本框 4">
            <a:extLst>
              <a:ext uri="{FF2B5EF4-FFF2-40B4-BE49-F238E27FC236}">
                <a16:creationId xmlns:a16="http://schemas.microsoft.com/office/drawing/2014/main" id="{B7D9E729-7114-BA0E-C81F-1A5049A8B98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180556" y="5137944"/>
            <a:ext cx="595313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5882" name="文本框 5">
            <a:extLst>
              <a:ext uri="{FF2B5EF4-FFF2-40B4-BE49-F238E27FC236}">
                <a16:creationId xmlns:a16="http://schemas.microsoft.com/office/drawing/2014/main" id="{A39FFE4B-91E7-D683-882C-6631F3B7B63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30600" y="5192713"/>
            <a:ext cx="50641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83" name="文本框 6">
            <a:extLst>
              <a:ext uri="{FF2B5EF4-FFF2-40B4-BE49-F238E27FC236}">
                <a16:creationId xmlns:a16="http://schemas.microsoft.com/office/drawing/2014/main" id="{7C6AF746-2B1A-A0AE-2B28-E0B0C1DC723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73501" y="5192712"/>
            <a:ext cx="5080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</a:p>
        </p:txBody>
      </p:sp>
      <p:sp>
        <p:nvSpPr>
          <p:cNvPr id="35884" name="文本框 7">
            <a:extLst>
              <a:ext uri="{FF2B5EF4-FFF2-40B4-BE49-F238E27FC236}">
                <a16:creationId xmlns:a16="http://schemas.microsoft.com/office/drawing/2014/main" id="{C9A6BE31-7698-6B83-2796-81E7C192DBA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071938" y="4945063"/>
            <a:ext cx="985837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85" name="文本框 8">
            <a:extLst>
              <a:ext uri="{FF2B5EF4-FFF2-40B4-BE49-F238E27FC236}">
                <a16:creationId xmlns:a16="http://schemas.microsoft.com/office/drawing/2014/main" id="{CEA3D611-A430-616C-BA29-8DC0FDC7AAA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341813" y="4945063"/>
            <a:ext cx="985837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86" name="文本框 9">
            <a:extLst>
              <a:ext uri="{FF2B5EF4-FFF2-40B4-BE49-F238E27FC236}">
                <a16:creationId xmlns:a16="http://schemas.microsoft.com/office/drawing/2014/main" id="{5420E476-8DA2-8B1E-2100-F62454D9C40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670426" y="4872037"/>
            <a:ext cx="11239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87" name="文本框 10">
            <a:extLst>
              <a:ext uri="{FF2B5EF4-FFF2-40B4-BE49-F238E27FC236}">
                <a16:creationId xmlns:a16="http://schemas.microsoft.com/office/drawing/2014/main" id="{4931F5D7-E9A8-E800-C0AB-31EA6E935E3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973638" y="4860925"/>
            <a:ext cx="11430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88" name="文本框 11">
            <a:extLst>
              <a:ext uri="{FF2B5EF4-FFF2-40B4-BE49-F238E27FC236}">
                <a16:creationId xmlns:a16="http://schemas.microsoft.com/office/drawing/2014/main" id="{6C4DAC8F-EE6B-1001-1F84-DCCE8513F21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314156" y="4869657"/>
            <a:ext cx="112712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89" name="文本框 9">
            <a:extLst>
              <a:ext uri="{FF2B5EF4-FFF2-40B4-BE49-F238E27FC236}">
                <a16:creationId xmlns:a16="http://schemas.microsoft.com/office/drawing/2014/main" id="{6CCE5580-AE1E-0D1F-EF0A-48ED564AB4B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586413" y="4870450"/>
            <a:ext cx="11239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90" name="文本框 10">
            <a:extLst>
              <a:ext uri="{FF2B5EF4-FFF2-40B4-BE49-F238E27FC236}">
                <a16:creationId xmlns:a16="http://schemas.microsoft.com/office/drawing/2014/main" id="{03F13EAB-B8E3-E64F-BAB4-365C4ED52E7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888831" y="4860132"/>
            <a:ext cx="11461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5891" name="文本框 11">
            <a:extLst>
              <a:ext uri="{FF2B5EF4-FFF2-40B4-BE49-F238E27FC236}">
                <a16:creationId xmlns:a16="http://schemas.microsoft.com/office/drawing/2014/main" id="{41F3ACCE-C48F-BF5A-7FC9-839B5755A8F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189663" y="4775200"/>
            <a:ext cx="13112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RU.521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TU2ZjdiN2JjZTY4ZGM3YWFmYzRjMTJiMDJlMzdkODEifQ=="/>
</p:tagLst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69</TotalTime>
  <Words>185</Words>
  <Application>Microsoft Macintosh PowerPoint</Application>
  <PresentationFormat>自定义</PresentationFormat>
  <Paragraphs>94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Times New Roman</vt:lpstr>
      <vt:lpstr>Office 2013 - 2022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cp:lastModifiedBy>18942356872@163.com</cp:lastModifiedBy>
  <cp:revision>78</cp:revision>
  <dcterms:created xsi:type="dcterms:W3CDTF">2024-12-08T09:18:18Z</dcterms:created>
  <dcterms:modified xsi:type="dcterms:W3CDTF">2025-12-20T10:12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321CCEA3293149FF97CD9B16CFEB8259_12</vt:lpwstr>
  </property>
</Properties>
</file>